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2" r:id="rId3"/>
  </p:sldIdLst>
  <p:sldSz cx="12192000" cy="6858000"/>
  <p:notesSz cx="7011988" cy="92979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E03BD"/>
    <a:srgbClr val="E226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95" d="100"/>
          <a:sy n="95" d="100"/>
        </p:scale>
        <p:origin x="2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99746F-1BE3-40A9-9488-D8AB64E2C3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F6ECCCA-33FB-451F-B301-9607CEA0DA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CA5187-BB75-4464-89B1-281FB35C3F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EE8ED5-1852-410A-B9A8-19EBA19DA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F1357E-3383-4422-99AE-7FF75D431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456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FEDD44-0B56-49D4-BBC7-CBD7FD8B32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AE312-1B96-4DF4-8975-719D87C255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6147A7-25DB-483B-8EBB-A436B7725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38E5E5-ADE7-4B0E-9568-833C0E0A6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332799-4B73-485D-9A1F-0C935CB2D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654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53EFC2-A5F7-450F-8EF1-25EF84B3B2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857DFB-1E70-4C0E-9E6B-A162F291D7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7A141A-B228-4E4D-A555-FE863F394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38D9E0-9D2D-4577-84E4-E12A609AB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6FB3D9-2E95-460A-98AE-343F0A3FBB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262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EDD743-C7AE-4332-A80C-A9B286BDB2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80DDD4-3C8E-4E44-9265-5E417C3441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D5D3DC-B4DA-4854-ADCB-D49AF6F60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FAB348-8763-4D0F-A866-119B45E03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A6187B-5018-46FF-9690-90FE80E65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654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CAB2E9-91A4-45EC-B08D-4D9E5429D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2154BB-92F3-480D-A2DC-A181DE7BDF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AC096-207D-4714-88DE-8C36F6287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9A4175-414A-4F57-A1A7-8EDC0828B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9D885A-6411-4932-B631-BAC17F50D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202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1CD6A1-25C7-4535-8A94-65911E9584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421ACC-A874-4A3F-9A73-C1EE35D721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542A9E-6D81-4193-8001-A977AC2999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B57488-54F1-426E-82DE-C043B9BD7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10E1C2-A369-471D-A217-D04F24B20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F0CC2F-59E7-4E28-BB74-DC8C28133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917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3F9B0C-9545-4CF0-A608-2F00115284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0C88A1-9EBF-49CA-85B0-124CC0A2AD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7E1BA4-05A9-43C1-A3B3-617E41CDA0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581136-97F9-428B-9D79-825C7798BA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7C66F81-79E8-4477-B152-0A9BFC0F03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EED27F3-C749-4B6F-B0E6-3D60A4CAF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FB896B-9600-4A5A-9DB6-D6AC633E7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B2E8BD-E4CD-44C8-9294-4A25D20D2D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895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C204EF-9538-4C14-83EC-37344EFBFE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1ECEFE-AC28-4B9D-AC14-821D577C7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8FBCB9-BAFE-4437-9EBF-E87DB4825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5B081DF-9C04-44E5-8323-9A3DC0881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919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DBEF520-8B00-4214-B6DB-E8A76173D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594C21-5B0E-4330-ABC5-C0CCA5CEE5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46601D-FFC3-4FEE-A93B-1A6CD0780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001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A863D6-68A0-44AD-8512-D5DC074883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0B16F9-767D-4251-8D27-A8452CC406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D37BD9-B31B-49EE-BA93-587BCDC77C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4D6C12-FA2D-47F7-8A91-43D3746F5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B29007-41E1-4E4A-BB64-D32E17A2F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6570F0-4F2F-47FA-B2D3-891CDC67B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800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B1E37B-C123-446C-94F7-67D80A5FD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DCA6CA-366E-4A1D-8E77-67A0E97B19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704742-9361-4B05-9CE6-287F1F7D0E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2B2EB7-5C11-48F1-9120-5B680EEBDF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292B4D-B3F6-4082-821B-0391F27F5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8349F2-503D-4920-8C39-8D5BCBB9E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886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96C635B-C308-47A9-960C-06D8391D0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6641AF-C827-4FB3-A2D2-7289E425FE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25CAF9-7568-4667-9217-11E31E5578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FF2428-CD70-4BD5-8FDE-3228258F875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7B9C7B-3C25-4AD5-865F-06AEA51A8D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FE8548-C687-4EB5-867A-B316C34063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6A9B78-2C1D-44D4-8720-4D7CBF1FF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226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69D6FE2C-B3B4-46B6-903D-75987753BAE9}"/>
              </a:ext>
            </a:extLst>
          </p:cNvPr>
          <p:cNvSpPr/>
          <p:nvPr/>
        </p:nvSpPr>
        <p:spPr>
          <a:xfrm>
            <a:off x="94004" y="18702"/>
            <a:ext cx="11177899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ially expressed gene signature (DEGs) based on next gene sequencing (mRNA sequencing)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R</a:t>
            </a:r>
            <a:r>
              <a:rPr lang="en-US" sz="1100" b="1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kumimoji="0" lang="en-US" sz="11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w</a:t>
            </a:r>
            <a:r>
              <a:rPr kumimoji="0" lang="en-US" sz="11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/mCRPC/NEPC (PC-3, PC-3M, DU145) vs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R</a:t>
            </a:r>
            <a:r>
              <a:rPr kumimoji="0" lang="en-US" sz="11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igh</a:t>
            </a:r>
            <a:r>
              <a:rPr kumimoji="0" lang="en-US" sz="11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/mCSPC (LNCaP, VCAP, 22RV1) prostate cancer (</a:t>
            </a:r>
            <a:r>
              <a:rPr kumimoji="0" lang="en-US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Ca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) cell lines and normal prostate cell lines RWPE1 and RWPE2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R"/>
              <a:tabLst/>
              <a:defRPr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Volcano plots representing mRNA expression for all cell lines. (b</a:t>
            </a:r>
            <a:r>
              <a:rPr lang="en-US" sz="11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e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&lt;0.05 and gray&gt;0.05)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R"/>
              <a:tabLst/>
              <a:defRPr/>
            </a:pP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tMap representing Differentially Expressed Gene Signature (DEGs) for AR</a:t>
            </a:r>
            <a:r>
              <a:rPr lang="en-US" sz="11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mCRPC/NEPC (PC-3, PC-3M, DU145) vs AR</a:t>
            </a:r>
            <a:r>
              <a:rPr lang="en-US" sz="11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mCSPC (LNCaP, VCAP, 22RV1) </a:t>
            </a:r>
            <a:r>
              <a:rPr lang="en-US" sz="11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a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normal prostate cell lines RWPE1 and RWPE2 (FDR&lt;0.05 and TOP-100)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89DA60C-36B0-41FA-A4C7-3750F6DC4570}"/>
              </a:ext>
            </a:extLst>
          </p:cNvPr>
          <p:cNvSpPr txBox="1"/>
          <p:nvPr/>
        </p:nvSpPr>
        <p:spPr>
          <a:xfrm>
            <a:off x="863125" y="1354155"/>
            <a:ext cx="2268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1A</a:t>
            </a:r>
            <a:endParaRPr lang="en-US" sz="1100" dirty="0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54BA51F8-5BA1-6F02-370D-FCDE3F390136}"/>
              </a:ext>
            </a:extLst>
          </p:cNvPr>
          <p:cNvGrpSpPr/>
          <p:nvPr/>
        </p:nvGrpSpPr>
        <p:grpSpPr>
          <a:xfrm>
            <a:off x="2630956" y="1354155"/>
            <a:ext cx="5538823" cy="5320113"/>
            <a:chOff x="2630956" y="1354155"/>
            <a:chExt cx="5538823" cy="5320113"/>
          </a:xfrm>
        </p:grpSpPr>
        <p:pic>
          <p:nvPicPr>
            <p:cNvPr id="2" name="Picture 1" descr="Chart, scatter chart&#10;&#10;Description automatically generated">
              <a:extLst>
                <a:ext uri="{FF2B5EF4-FFF2-40B4-BE49-F238E27FC236}">
                  <a16:creationId xmlns:a16="http://schemas.microsoft.com/office/drawing/2014/main" id="{F1AD2F10-08E3-458D-BA99-29210C4AFB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890" t="1389" r="20517" b="2897"/>
            <a:stretch/>
          </p:blipFill>
          <p:spPr>
            <a:xfrm>
              <a:off x="2697620" y="1354155"/>
              <a:ext cx="5472159" cy="52859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4FEC696-2243-250E-98D5-4A1A7E589235}"/>
                </a:ext>
              </a:extLst>
            </p:cNvPr>
            <p:cNvSpPr txBox="1"/>
            <p:nvPr/>
          </p:nvSpPr>
          <p:spPr>
            <a:xfrm>
              <a:off x="3982341" y="6397269"/>
              <a:ext cx="35269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old Change (Aggressive vs Non-Aggressive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A8668E3-A8FB-1A22-E124-DFEEBB57255C}"/>
                </a:ext>
              </a:extLst>
            </p:cNvPr>
            <p:cNvSpPr txBox="1"/>
            <p:nvPr/>
          </p:nvSpPr>
          <p:spPr>
            <a:xfrm rot="16200000">
              <a:off x="1199955" y="3679984"/>
              <a:ext cx="31390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-value (Aggressive vs Non-Aggressive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804534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Group 92">
            <a:extLst>
              <a:ext uri="{FF2B5EF4-FFF2-40B4-BE49-F238E27FC236}">
                <a16:creationId xmlns:a16="http://schemas.microsoft.com/office/drawing/2014/main" id="{B86AE470-82F6-449D-BD84-CBCC366BA516}"/>
              </a:ext>
            </a:extLst>
          </p:cNvPr>
          <p:cNvGrpSpPr/>
          <p:nvPr/>
        </p:nvGrpSpPr>
        <p:grpSpPr>
          <a:xfrm>
            <a:off x="2119357" y="-22810"/>
            <a:ext cx="3161225" cy="6879236"/>
            <a:chOff x="5677640" y="-7620"/>
            <a:chExt cx="3161225" cy="6879236"/>
          </a:xfrm>
        </p:grpSpPr>
        <p:pic>
          <p:nvPicPr>
            <p:cNvPr id="5" name="Picture 4" descr="Graphical user interface, chart, treemap chart&#10;&#10;Description automatically generated">
              <a:extLst>
                <a:ext uri="{FF2B5EF4-FFF2-40B4-BE49-F238E27FC236}">
                  <a16:creationId xmlns:a16="http://schemas.microsoft.com/office/drawing/2014/main" id="{1AC4EABE-7549-487F-9632-7D5BBAA956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4551" r="5078" b="9400"/>
            <a:stretch/>
          </p:blipFill>
          <p:spPr>
            <a:xfrm rot="5400000">
              <a:off x="4089463" y="2271875"/>
              <a:ext cx="6758175" cy="2309676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F5EE3B4-8764-4A6B-9620-792A9322E1B7}"/>
                </a:ext>
              </a:extLst>
            </p:cNvPr>
            <p:cNvSpPr txBox="1"/>
            <p:nvPr/>
          </p:nvSpPr>
          <p:spPr>
            <a:xfrm>
              <a:off x="5877714" y="220296"/>
              <a:ext cx="5261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LAMB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200F140-2736-4A54-83A8-99EFEDD713F4}"/>
                </a:ext>
              </a:extLst>
            </p:cNvPr>
            <p:cNvSpPr txBox="1"/>
            <p:nvPr/>
          </p:nvSpPr>
          <p:spPr>
            <a:xfrm>
              <a:off x="5919255" y="317407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SOD 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F7EB614-F455-47FF-9F77-9C39B194EE57}"/>
                </a:ext>
              </a:extLst>
            </p:cNvPr>
            <p:cNvSpPr txBox="1"/>
            <p:nvPr/>
          </p:nvSpPr>
          <p:spPr>
            <a:xfrm>
              <a:off x="5677640" y="419310"/>
              <a:ext cx="7184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ELFN1-AS 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BDE4299-9F6D-4471-9AA2-D280DE490449}"/>
                </a:ext>
              </a:extLst>
            </p:cNvPr>
            <p:cNvSpPr txBox="1"/>
            <p:nvPr/>
          </p:nvSpPr>
          <p:spPr>
            <a:xfrm>
              <a:off x="5736787" y="516421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RHGEF 6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B2E4F42-3444-41D0-BC45-F9890F50A259}"/>
                </a:ext>
              </a:extLst>
            </p:cNvPr>
            <p:cNvSpPr txBox="1"/>
            <p:nvPr/>
          </p:nvSpPr>
          <p:spPr>
            <a:xfrm>
              <a:off x="5875711" y="627288"/>
              <a:ext cx="5212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ENPP 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9ADCF2F-05E1-4988-AC5B-027ECF752E91}"/>
                </a:ext>
              </a:extLst>
            </p:cNvPr>
            <p:cNvSpPr txBox="1"/>
            <p:nvPr/>
          </p:nvSpPr>
          <p:spPr>
            <a:xfrm>
              <a:off x="5926285" y="726223"/>
              <a:ext cx="4748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NRG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9AA0D9E-B281-4FE1-A294-61F2C58D3666}"/>
                </a:ext>
              </a:extLst>
            </p:cNvPr>
            <p:cNvSpPr txBox="1"/>
            <p:nvPr/>
          </p:nvSpPr>
          <p:spPr>
            <a:xfrm>
              <a:off x="5786466" y="822190"/>
              <a:ext cx="6158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COL13A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933C715-1474-4E80-89E0-7744EBC83CA2}"/>
                </a:ext>
              </a:extLst>
            </p:cNvPr>
            <p:cNvSpPr txBox="1"/>
            <p:nvPr/>
          </p:nvSpPr>
          <p:spPr>
            <a:xfrm>
              <a:off x="5943219" y="923850"/>
              <a:ext cx="4491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GOS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DF6894A-DE74-47F1-AC97-6AE78FCBA2F7}"/>
                </a:ext>
              </a:extLst>
            </p:cNvPr>
            <p:cNvSpPr txBox="1"/>
            <p:nvPr/>
          </p:nvSpPr>
          <p:spPr>
            <a:xfrm>
              <a:off x="5882522" y="1028376"/>
              <a:ext cx="51648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COX2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E69D5D4-1ECF-4DDB-B416-5566DE926F37}"/>
                </a:ext>
              </a:extLst>
            </p:cNvPr>
            <p:cNvSpPr txBox="1"/>
            <p:nvPr/>
          </p:nvSpPr>
          <p:spPr>
            <a:xfrm>
              <a:off x="5834172" y="1127802"/>
              <a:ext cx="5645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TBXA2R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3B74783-45C5-4959-89DE-BDDD85E1A1CC}"/>
                </a:ext>
              </a:extLst>
            </p:cNvPr>
            <p:cNvSpPr txBox="1"/>
            <p:nvPr/>
          </p:nvSpPr>
          <p:spPr>
            <a:xfrm>
              <a:off x="5808045" y="1238669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LONR F2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056F159-855D-402E-BDF0-ACC1BE4C85AE}"/>
                </a:ext>
              </a:extLst>
            </p:cNvPr>
            <p:cNvSpPr txBox="1"/>
            <p:nvPr/>
          </p:nvSpPr>
          <p:spPr>
            <a:xfrm>
              <a:off x="5888579" y="1331754"/>
              <a:ext cx="51007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LCH 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E00E8CE-C6BB-47BE-B906-CBABC5AFAC63}"/>
                </a:ext>
              </a:extLst>
            </p:cNvPr>
            <p:cNvSpPr txBox="1"/>
            <p:nvPr/>
          </p:nvSpPr>
          <p:spPr>
            <a:xfrm>
              <a:off x="5854438" y="1439822"/>
              <a:ext cx="54694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SLAIN 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276A8D5-6D8D-4459-BB6D-AB9CE052E400}"/>
                </a:ext>
              </a:extLst>
            </p:cNvPr>
            <p:cNvSpPr txBox="1"/>
            <p:nvPr/>
          </p:nvSpPr>
          <p:spPr>
            <a:xfrm>
              <a:off x="5887236" y="1535183"/>
              <a:ext cx="5036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COX2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1280154-4BA7-47B6-B919-F97617338C3C}"/>
                </a:ext>
              </a:extLst>
            </p:cNvPr>
            <p:cNvSpPr txBox="1"/>
            <p:nvPr/>
          </p:nvSpPr>
          <p:spPr>
            <a:xfrm>
              <a:off x="5974316" y="1643774"/>
              <a:ext cx="41870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FF3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E4C9352-79EA-4465-9036-7982098D7D98}"/>
                </a:ext>
              </a:extLst>
            </p:cNvPr>
            <p:cNvSpPr txBox="1"/>
            <p:nvPr/>
          </p:nvSpPr>
          <p:spPr>
            <a:xfrm>
              <a:off x="5932535" y="1742744"/>
              <a:ext cx="4683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OTEI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E02B105-1AE5-42CB-905A-182FDA583743}"/>
                </a:ext>
              </a:extLst>
            </p:cNvPr>
            <p:cNvSpPr txBox="1"/>
            <p:nvPr/>
          </p:nvSpPr>
          <p:spPr>
            <a:xfrm>
              <a:off x="5897288" y="1840353"/>
              <a:ext cx="50206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CENPX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AD470D8-578D-4B93-B5F9-7A0C22FE2AEB}"/>
                </a:ext>
              </a:extLst>
            </p:cNvPr>
            <p:cNvSpPr txBox="1"/>
            <p:nvPr/>
          </p:nvSpPr>
          <p:spPr>
            <a:xfrm>
              <a:off x="5856746" y="1942114"/>
              <a:ext cx="5453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GTF3C6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91C3112-A45D-47C4-9585-F30F772B2159}"/>
                </a:ext>
              </a:extLst>
            </p:cNvPr>
            <p:cNvSpPr txBox="1"/>
            <p:nvPr/>
          </p:nvSpPr>
          <p:spPr>
            <a:xfrm>
              <a:off x="5876386" y="2050215"/>
              <a:ext cx="52770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TRPM2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CB5809B-B628-4B32-8CBC-74F9904CF143}"/>
                </a:ext>
              </a:extLst>
            </p:cNvPr>
            <p:cNvSpPr txBox="1"/>
            <p:nvPr/>
          </p:nvSpPr>
          <p:spPr>
            <a:xfrm>
              <a:off x="5811745" y="2147326"/>
              <a:ext cx="59182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STXBP5L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CE7EACD-3D50-4597-B526-F108172A8118}"/>
                </a:ext>
              </a:extLst>
            </p:cNvPr>
            <p:cNvSpPr txBox="1"/>
            <p:nvPr/>
          </p:nvSpPr>
          <p:spPr>
            <a:xfrm>
              <a:off x="5902531" y="2251368"/>
              <a:ext cx="4892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YCR3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8D10590-EFBF-4A04-B02E-7575EBA80D20}"/>
                </a:ext>
              </a:extLst>
            </p:cNvPr>
            <p:cNvSpPr txBox="1"/>
            <p:nvPr/>
          </p:nvSpPr>
          <p:spPr>
            <a:xfrm>
              <a:off x="5852069" y="2350922"/>
              <a:ext cx="5389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RAME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CCB358A-2CA6-4774-90AF-1A81C4E86852}"/>
                </a:ext>
              </a:extLst>
            </p:cNvPr>
            <p:cNvSpPr txBox="1"/>
            <p:nvPr/>
          </p:nvSpPr>
          <p:spPr>
            <a:xfrm>
              <a:off x="5715470" y="2450412"/>
              <a:ext cx="68800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TRPM2-AS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5AC68B3-178D-4DA7-B2A7-C6F24D4A9DFC}"/>
                </a:ext>
              </a:extLst>
            </p:cNvPr>
            <p:cNvSpPr txBox="1"/>
            <p:nvPr/>
          </p:nvSpPr>
          <p:spPr>
            <a:xfrm>
              <a:off x="5811854" y="2554290"/>
              <a:ext cx="5838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GPR 158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1FE15A0-68D5-4584-89D2-8FB0DF521A2F}"/>
                </a:ext>
              </a:extLst>
            </p:cNvPr>
            <p:cNvSpPr txBox="1"/>
            <p:nvPr/>
          </p:nvSpPr>
          <p:spPr>
            <a:xfrm>
              <a:off x="5828969" y="2659358"/>
              <a:ext cx="56618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LR RC7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F1E87FB-3F8B-436D-A3F8-9BB4DA2B30B2}"/>
                </a:ext>
              </a:extLst>
            </p:cNvPr>
            <p:cNvSpPr txBox="1"/>
            <p:nvPr/>
          </p:nvSpPr>
          <p:spPr>
            <a:xfrm>
              <a:off x="5820753" y="2764873"/>
              <a:ext cx="5822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FRG 1CP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C521CC8-7408-420A-8B4B-537C0414DD43}"/>
                </a:ext>
              </a:extLst>
            </p:cNvPr>
            <p:cNvSpPr txBox="1"/>
            <p:nvPr/>
          </p:nvSpPr>
          <p:spPr>
            <a:xfrm>
              <a:off x="5824909" y="2866761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NKS1B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E6CB9C0-C385-4D9E-8E29-F5E2080622E7}"/>
                </a:ext>
              </a:extLst>
            </p:cNvPr>
            <p:cNvSpPr txBox="1"/>
            <p:nvPr/>
          </p:nvSpPr>
          <p:spPr>
            <a:xfrm>
              <a:off x="5762533" y="2966251"/>
              <a:ext cx="63190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RKAR2B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1AAC7F0-4F0A-4CC5-98C2-74BDF3B4A7DA}"/>
                </a:ext>
              </a:extLst>
            </p:cNvPr>
            <p:cNvSpPr txBox="1"/>
            <p:nvPr/>
          </p:nvSpPr>
          <p:spPr>
            <a:xfrm>
              <a:off x="5893155" y="3067430"/>
              <a:ext cx="49564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DE3B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345EA99-9249-41EC-ACC9-43AD595DB2B1}"/>
                </a:ext>
              </a:extLst>
            </p:cNvPr>
            <p:cNvSpPr txBox="1"/>
            <p:nvPr/>
          </p:nvSpPr>
          <p:spPr>
            <a:xfrm>
              <a:off x="5845463" y="3171443"/>
              <a:ext cx="5421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STEAP2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7F17EA7-FBF6-438B-B8ED-C9676A3AC684}"/>
                </a:ext>
              </a:extLst>
            </p:cNvPr>
            <p:cNvSpPr txBox="1"/>
            <p:nvPr/>
          </p:nvSpPr>
          <p:spPr>
            <a:xfrm>
              <a:off x="5819323" y="3272102"/>
              <a:ext cx="5757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RUNE2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38A39CA-AA8A-4170-AEA1-EEB448772D27}"/>
                </a:ext>
              </a:extLst>
            </p:cNvPr>
            <p:cNvSpPr txBox="1"/>
            <p:nvPr/>
          </p:nvSpPr>
          <p:spPr>
            <a:xfrm>
              <a:off x="5916360" y="3379745"/>
              <a:ext cx="4812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SPDEF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E3A127F-6F2D-48D2-8B68-D97CB3096AD9}"/>
                </a:ext>
              </a:extLst>
            </p:cNvPr>
            <p:cNvSpPr txBox="1"/>
            <p:nvPr/>
          </p:nvSpPr>
          <p:spPr>
            <a:xfrm>
              <a:off x="5812595" y="3475207"/>
              <a:ext cx="59343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HNAK2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2AD0470-D48D-40E8-B9CF-0D56F2E24FA4}"/>
                </a:ext>
              </a:extLst>
            </p:cNvPr>
            <p:cNvSpPr txBox="1"/>
            <p:nvPr/>
          </p:nvSpPr>
          <p:spPr>
            <a:xfrm>
              <a:off x="5929474" y="3573015"/>
              <a:ext cx="4683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ITGB4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CDC3D5F-16EF-4D47-8105-E68019AE7D27}"/>
                </a:ext>
              </a:extLst>
            </p:cNvPr>
            <p:cNvSpPr txBox="1"/>
            <p:nvPr/>
          </p:nvSpPr>
          <p:spPr>
            <a:xfrm>
              <a:off x="6027332" y="3673378"/>
              <a:ext cx="3722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DSP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C30C495-A111-4D62-9558-9297225A8ECF}"/>
                </a:ext>
              </a:extLst>
            </p:cNvPr>
            <p:cNvSpPr txBox="1"/>
            <p:nvPr/>
          </p:nvSpPr>
          <p:spPr>
            <a:xfrm>
              <a:off x="5870377" y="3773001"/>
              <a:ext cx="5325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LAMA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409C21B-BB61-4A53-93E0-F219348D616F}"/>
                </a:ext>
              </a:extLst>
            </p:cNvPr>
            <p:cNvSpPr txBox="1"/>
            <p:nvPr/>
          </p:nvSpPr>
          <p:spPr>
            <a:xfrm>
              <a:off x="5829934" y="3880946"/>
              <a:ext cx="5741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SPRP 1B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DACB1E9-A3B0-4FBF-97D4-30BE72C559E5}"/>
                </a:ext>
              </a:extLst>
            </p:cNvPr>
            <p:cNvSpPr txBox="1"/>
            <p:nvPr/>
          </p:nvSpPr>
          <p:spPr>
            <a:xfrm>
              <a:off x="5925945" y="3979585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MAFB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80D6A6AC-8EAA-4011-8A72-0AE730F42E38}"/>
                </a:ext>
              </a:extLst>
            </p:cNvPr>
            <p:cNvSpPr txBox="1"/>
            <p:nvPr/>
          </p:nvSpPr>
          <p:spPr>
            <a:xfrm>
              <a:off x="5874572" y="4084342"/>
              <a:ext cx="52770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CELSR2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F498861-C85D-476F-8DDA-DE3DA4135C70}"/>
                </a:ext>
              </a:extLst>
            </p:cNvPr>
            <p:cNvSpPr txBox="1"/>
            <p:nvPr/>
          </p:nvSpPr>
          <p:spPr>
            <a:xfrm>
              <a:off x="5764917" y="4183789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TRAF3IP2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A4FCAD7-B029-4F63-BB6D-90C208381348}"/>
                </a:ext>
              </a:extLst>
            </p:cNvPr>
            <p:cNvSpPr txBox="1"/>
            <p:nvPr/>
          </p:nvSpPr>
          <p:spPr>
            <a:xfrm>
              <a:off x="5870166" y="4286146"/>
              <a:ext cx="52770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NIPAL4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D79ED35-75FF-4A5F-8AF2-5851E0F663F4}"/>
                </a:ext>
              </a:extLst>
            </p:cNvPr>
            <p:cNvSpPr txBox="1"/>
            <p:nvPr/>
          </p:nvSpPr>
          <p:spPr>
            <a:xfrm>
              <a:off x="5892998" y="4386634"/>
              <a:ext cx="5036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4HA2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56157DC-AF9F-4E29-8600-97441A9F9DA2}"/>
                </a:ext>
              </a:extLst>
            </p:cNvPr>
            <p:cNvSpPr txBox="1"/>
            <p:nvPr/>
          </p:nvSpPr>
          <p:spPr>
            <a:xfrm>
              <a:off x="5906165" y="4485462"/>
              <a:ext cx="4844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LCH2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779EA8F1-C7DC-4894-AFDF-C4A4AE6946C4}"/>
                </a:ext>
              </a:extLst>
            </p:cNvPr>
            <p:cNvSpPr txBox="1"/>
            <p:nvPr/>
          </p:nvSpPr>
          <p:spPr>
            <a:xfrm>
              <a:off x="5938081" y="4582215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DPN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37FEC2F-D929-4690-B1DE-C788A45BEB88}"/>
                </a:ext>
              </a:extLst>
            </p:cNvPr>
            <p:cNvSpPr txBox="1"/>
            <p:nvPr/>
          </p:nvSpPr>
          <p:spPr>
            <a:xfrm>
              <a:off x="5868218" y="4687787"/>
              <a:ext cx="5341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IL20R B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2221201-5246-4D8B-83E9-7357D71C23AC}"/>
                </a:ext>
              </a:extLst>
            </p:cNvPr>
            <p:cNvSpPr txBox="1"/>
            <p:nvPr/>
          </p:nvSpPr>
          <p:spPr>
            <a:xfrm>
              <a:off x="5850803" y="4792310"/>
              <a:ext cx="554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TRIM29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23A42FF5-B386-4C3E-BCF8-1EA3356FC135}"/>
                </a:ext>
              </a:extLst>
            </p:cNvPr>
            <p:cNvSpPr txBox="1"/>
            <p:nvPr/>
          </p:nvSpPr>
          <p:spPr>
            <a:xfrm>
              <a:off x="5745080" y="4897143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RHGEF 4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0BDAD64B-7D26-4514-A8B9-E0BC7F0B9D40}"/>
                </a:ext>
              </a:extLst>
            </p:cNvPr>
            <p:cNvSpPr txBox="1"/>
            <p:nvPr/>
          </p:nvSpPr>
          <p:spPr>
            <a:xfrm>
              <a:off x="6009148" y="4996585"/>
              <a:ext cx="3834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JMY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4FAB53B3-09F7-4DF0-ABE8-3073A0CA53C8}"/>
                </a:ext>
              </a:extLst>
            </p:cNvPr>
            <p:cNvSpPr txBox="1"/>
            <p:nvPr/>
          </p:nvSpPr>
          <p:spPr>
            <a:xfrm>
              <a:off x="5801491" y="5102977"/>
              <a:ext cx="59824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S100A14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2D88F37-3172-49AA-8A6E-EE3D0C54993A}"/>
                </a:ext>
              </a:extLst>
            </p:cNvPr>
            <p:cNvSpPr txBox="1"/>
            <p:nvPr/>
          </p:nvSpPr>
          <p:spPr>
            <a:xfrm>
              <a:off x="5816989" y="5207810"/>
              <a:ext cx="5870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HOXD11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AB4F639-C344-43A5-8516-E5CB8C255F2F}"/>
                </a:ext>
              </a:extLst>
            </p:cNvPr>
            <p:cNvSpPr txBox="1"/>
            <p:nvPr/>
          </p:nvSpPr>
          <p:spPr>
            <a:xfrm>
              <a:off x="5769742" y="5300665"/>
              <a:ext cx="62388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NECTIN 1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84FC715-76A9-400D-9E63-34F85874A6BA}"/>
                </a:ext>
              </a:extLst>
            </p:cNvPr>
            <p:cNvSpPr txBox="1"/>
            <p:nvPr/>
          </p:nvSpPr>
          <p:spPr>
            <a:xfrm>
              <a:off x="5790331" y="5405439"/>
              <a:ext cx="59824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DBNDD2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8C4F0338-2E3F-41C9-B851-0C58519528C0}"/>
                </a:ext>
              </a:extLst>
            </p:cNvPr>
            <p:cNvSpPr txBox="1"/>
            <p:nvPr/>
          </p:nvSpPr>
          <p:spPr>
            <a:xfrm>
              <a:off x="5965268" y="5504800"/>
              <a:ext cx="4299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SDC4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4C688D68-70B1-4865-AF17-E2D863BAF14A}"/>
                </a:ext>
              </a:extLst>
            </p:cNvPr>
            <p:cNvSpPr txBox="1"/>
            <p:nvPr/>
          </p:nvSpPr>
          <p:spPr>
            <a:xfrm>
              <a:off x="5878527" y="5611332"/>
              <a:ext cx="5180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UNC5B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0082A1C0-628C-400A-A0BE-28F99712A5EC}"/>
                </a:ext>
              </a:extLst>
            </p:cNvPr>
            <p:cNvSpPr txBox="1"/>
            <p:nvPr/>
          </p:nvSpPr>
          <p:spPr>
            <a:xfrm>
              <a:off x="5756585" y="5708069"/>
              <a:ext cx="6415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OLFML2A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22C4C9F0-2727-4A1F-A908-5528DA71F4E0}"/>
                </a:ext>
              </a:extLst>
            </p:cNvPr>
            <p:cNvSpPr txBox="1"/>
            <p:nvPr/>
          </p:nvSpPr>
          <p:spPr>
            <a:xfrm>
              <a:off x="5854111" y="5805879"/>
              <a:ext cx="54053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RASSF5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4563E529-5875-448C-AA00-F1DFA6FAD2C3}"/>
                </a:ext>
              </a:extLst>
            </p:cNvPr>
            <p:cNvSpPr txBox="1"/>
            <p:nvPr/>
          </p:nvSpPr>
          <p:spPr>
            <a:xfrm>
              <a:off x="5848251" y="5913790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IGF BP7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4E0C65AD-29AC-4B49-9855-5E96DD4115A1}"/>
                </a:ext>
              </a:extLst>
            </p:cNvPr>
            <p:cNvSpPr txBox="1"/>
            <p:nvPr/>
          </p:nvSpPr>
          <p:spPr>
            <a:xfrm>
              <a:off x="5965347" y="6009632"/>
              <a:ext cx="4235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FAT2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42BABCD-15FE-4C0D-BAE2-D5E3BF7F120E}"/>
                </a:ext>
              </a:extLst>
            </p:cNvPr>
            <p:cNvSpPr txBox="1"/>
            <p:nvPr/>
          </p:nvSpPr>
          <p:spPr>
            <a:xfrm>
              <a:off x="5729492" y="6113390"/>
              <a:ext cx="66236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MAPKBP1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D265F569-4BB7-4692-B72A-2D5CF1394949}"/>
                </a:ext>
              </a:extLst>
            </p:cNvPr>
            <p:cNvSpPr txBox="1"/>
            <p:nvPr/>
          </p:nvSpPr>
          <p:spPr>
            <a:xfrm>
              <a:off x="5775635" y="6215360"/>
              <a:ext cx="62388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CSNK2A2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B2E32BC-16CB-46DD-B58B-FB5B0769940B}"/>
                </a:ext>
              </a:extLst>
            </p:cNvPr>
            <p:cNvSpPr txBox="1"/>
            <p:nvPr/>
          </p:nvSpPr>
          <p:spPr>
            <a:xfrm>
              <a:off x="5823260" y="6312866"/>
              <a:ext cx="5822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DL1M1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DDF86323-3FA6-43F5-8562-63B8CF62B5A8}"/>
                </a:ext>
              </a:extLst>
            </p:cNvPr>
            <p:cNvSpPr txBox="1"/>
            <p:nvPr/>
          </p:nvSpPr>
          <p:spPr>
            <a:xfrm>
              <a:off x="5908309" y="6418547"/>
              <a:ext cx="49084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ITPRIP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FA730B62-7EC2-4B32-9AC0-3AF17E9E761E}"/>
                </a:ext>
              </a:extLst>
            </p:cNvPr>
            <p:cNvSpPr txBox="1"/>
            <p:nvPr/>
          </p:nvSpPr>
          <p:spPr>
            <a:xfrm>
              <a:off x="5805629" y="6533808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MMP 14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B180B3F-AD6F-40DF-BA76-985A42CC0416}"/>
                </a:ext>
              </a:extLst>
            </p:cNvPr>
            <p:cNvSpPr txBox="1"/>
            <p:nvPr/>
          </p:nvSpPr>
          <p:spPr>
            <a:xfrm>
              <a:off x="5838639" y="6640784"/>
              <a:ext cx="5645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RNASE7</a:t>
              </a:r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1B377772-4BCA-4849-84EF-0A703775DBE2}"/>
                </a:ext>
              </a:extLst>
            </p:cNvPr>
            <p:cNvSpPr/>
            <p:nvPr/>
          </p:nvSpPr>
          <p:spPr>
            <a:xfrm>
              <a:off x="6492492" y="68889"/>
              <a:ext cx="297726" cy="85282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11C27D6B-2B8E-4DEC-83FF-3797AC4340A9}"/>
                </a:ext>
              </a:extLst>
            </p:cNvPr>
            <p:cNvSpPr txBox="1"/>
            <p:nvPr/>
          </p:nvSpPr>
          <p:spPr>
            <a:xfrm>
              <a:off x="6318008" y="582"/>
              <a:ext cx="62388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NORMAL</a:t>
              </a: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EC51DCF-51A6-4990-8868-72FD2E314BCC}"/>
                </a:ext>
              </a:extLst>
            </p:cNvPr>
            <p:cNvSpPr/>
            <p:nvPr/>
          </p:nvSpPr>
          <p:spPr>
            <a:xfrm>
              <a:off x="6317522" y="198369"/>
              <a:ext cx="273954" cy="603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BCC056CC-842E-4F30-9B87-B1F21E8C6058}"/>
                </a:ext>
              </a:extLst>
            </p:cNvPr>
            <p:cNvSpPr txBox="1"/>
            <p:nvPr/>
          </p:nvSpPr>
          <p:spPr>
            <a:xfrm>
              <a:off x="6233634" y="123917"/>
              <a:ext cx="4539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RWPE2</a:t>
              </a:r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246A7307-A295-4154-91FF-C164F93C789E}"/>
                </a:ext>
              </a:extLst>
            </p:cNvPr>
            <p:cNvSpPr/>
            <p:nvPr/>
          </p:nvSpPr>
          <p:spPr>
            <a:xfrm>
              <a:off x="6607241" y="201251"/>
              <a:ext cx="273954" cy="603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91D36713-F888-4575-A54D-8C6B55965E6A}"/>
                </a:ext>
              </a:extLst>
            </p:cNvPr>
            <p:cNvSpPr/>
            <p:nvPr/>
          </p:nvSpPr>
          <p:spPr>
            <a:xfrm>
              <a:off x="6900375" y="198369"/>
              <a:ext cx="273954" cy="603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21B8BD0E-8A33-45F6-AC5B-740F4FB5C915}"/>
                </a:ext>
              </a:extLst>
            </p:cNvPr>
            <p:cNvSpPr/>
            <p:nvPr/>
          </p:nvSpPr>
          <p:spPr>
            <a:xfrm>
              <a:off x="7182474" y="205621"/>
              <a:ext cx="273954" cy="603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FAD6D78F-58EA-4E63-858F-DC4695C883DA}"/>
                </a:ext>
              </a:extLst>
            </p:cNvPr>
            <p:cNvSpPr/>
            <p:nvPr/>
          </p:nvSpPr>
          <p:spPr>
            <a:xfrm>
              <a:off x="7476345" y="198369"/>
              <a:ext cx="273954" cy="603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853B3396-339B-4242-8680-5BDE4BED36F4}"/>
                </a:ext>
              </a:extLst>
            </p:cNvPr>
            <p:cNvSpPr txBox="1"/>
            <p:nvPr/>
          </p:nvSpPr>
          <p:spPr>
            <a:xfrm>
              <a:off x="6523387" y="125565"/>
              <a:ext cx="4539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RWPE1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E331729-A16D-4937-AD1D-E1C5ACD7C828}"/>
                </a:ext>
              </a:extLst>
            </p:cNvPr>
            <p:cNvSpPr txBox="1"/>
            <p:nvPr/>
          </p:nvSpPr>
          <p:spPr>
            <a:xfrm>
              <a:off x="6838032" y="128504"/>
              <a:ext cx="3882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VCAP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1E846C49-9D0E-486D-8047-F434BEF2AE1B}"/>
                </a:ext>
              </a:extLst>
            </p:cNvPr>
            <p:cNvSpPr txBox="1"/>
            <p:nvPr/>
          </p:nvSpPr>
          <p:spPr>
            <a:xfrm>
              <a:off x="7117596" y="128136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22RV1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24211565-5094-4B01-B2C9-743E173C1B33}"/>
                </a:ext>
              </a:extLst>
            </p:cNvPr>
            <p:cNvSpPr txBox="1"/>
            <p:nvPr/>
          </p:nvSpPr>
          <p:spPr>
            <a:xfrm>
              <a:off x="7402631" y="128551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NCaP</a:t>
              </a:r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71846F83-879E-485E-A0F3-185BC325A5A5}"/>
                </a:ext>
              </a:extLst>
            </p:cNvPr>
            <p:cNvSpPr/>
            <p:nvPr/>
          </p:nvSpPr>
          <p:spPr>
            <a:xfrm>
              <a:off x="7766965" y="198000"/>
              <a:ext cx="273954" cy="603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01A5F686-A805-403B-9FBE-D085AF8CD3D3}"/>
                </a:ext>
              </a:extLst>
            </p:cNvPr>
            <p:cNvSpPr/>
            <p:nvPr/>
          </p:nvSpPr>
          <p:spPr>
            <a:xfrm>
              <a:off x="8052819" y="200071"/>
              <a:ext cx="273954" cy="603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869306AC-E25B-49F5-91F8-118939AF5D10}"/>
                </a:ext>
              </a:extLst>
            </p:cNvPr>
            <p:cNvSpPr/>
            <p:nvPr/>
          </p:nvSpPr>
          <p:spPr>
            <a:xfrm>
              <a:off x="8342078" y="198000"/>
              <a:ext cx="273954" cy="603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6F372ADA-5B40-4BE9-8BC2-18E7BC88078F}"/>
                </a:ext>
              </a:extLst>
            </p:cNvPr>
            <p:cNvSpPr txBox="1"/>
            <p:nvPr/>
          </p:nvSpPr>
          <p:spPr>
            <a:xfrm>
              <a:off x="7686089" y="128135"/>
              <a:ext cx="4315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C-3M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153FFAE0-E69C-40C5-9753-8E011B60D71E}"/>
                </a:ext>
              </a:extLst>
            </p:cNvPr>
            <p:cNvSpPr txBox="1"/>
            <p:nvPr/>
          </p:nvSpPr>
          <p:spPr>
            <a:xfrm>
              <a:off x="7977386" y="128134"/>
              <a:ext cx="4347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DU145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D03F3729-9E85-4AF0-8AD3-A0FDE1485554}"/>
                </a:ext>
              </a:extLst>
            </p:cNvPr>
            <p:cNvSpPr txBox="1"/>
            <p:nvPr/>
          </p:nvSpPr>
          <p:spPr>
            <a:xfrm>
              <a:off x="8320899" y="128136"/>
              <a:ext cx="3529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C-3</a:t>
              </a:r>
            </a:p>
          </p:txBody>
        </p: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ADE6E537-0704-4FF3-B84E-23F4009F792A}"/>
                </a:ext>
              </a:extLst>
            </p:cNvPr>
            <p:cNvSpPr/>
            <p:nvPr/>
          </p:nvSpPr>
          <p:spPr>
            <a:xfrm>
              <a:off x="7108161" y="96385"/>
              <a:ext cx="404278" cy="6032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9357A5E5-B89E-4625-B813-CEEEFDA25AEE}"/>
                </a:ext>
              </a:extLst>
            </p:cNvPr>
            <p:cNvSpPr txBox="1"/>
            <p:nvPr/>
          </p:nvSpPr>
          <p:spPr>
            <a:xfrm>
              <a:off x="6954881" y="-3339"/>
              <a:ext cx="86914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R</a:t>
              </a:r>
              <a:r>
                <a:rPr lang="en-US" sz="900" b="1" baseline="30000" dirty="0"/>
                <a:t>HIGH</a:t>
              </a:r>
              <a:r>
                <a:rPr lang="en-US" sz="900" b="1" dirty="0"/>
                <a:t>/mCSPC</a:t>
              </a:r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5F059BE3-6987-4487-8A8B-51ABCAE6038D}"/>
                </a:ext>
              </a:extLst>
            </p:cNvPr>
            <p:cNvSpPr/>
            <p:nvPr/>
          </p:nvSpPr>
          <p:spPr>
            <a:xfrm>
              <a:off x="8052819" y="111530"/>
              <a:ext cx="275184" cy="45719"/>
            </a:xfrm>
            <a:prstGeom prst="rect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41A23FF7-3DE4-4BA7-9187-E3139AC75EA9}"/>
                </a:ext>
              </a:extLst>
            </p:cNvPr>
            <p:cNvSpPr txBox="1"/>
            <p:nvPr/>
          </p:nvSpPr>
          <p:spPr>
            <a:xfrm>
              <a:off x="7668352" y="-7620"/>
              <a:ext cx="11705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R</a:t>
              </a:r>
              <a:r>
                <a:rPr lang="en-US" sz="900" b="1" baseline="30000" dirty="0"/>
                <a:t>LOW</a:t>
              </a:r>
              <a:r>
                <a:rPr lang="en-US" sz="900" b="1" dirty="0"/>
                <a:t>/mCRPC/NEPC</a:t>
              </a:r>
            </a:p>
          </p:txBody>
        </p:sp>
      </p:grpSp>
      <p:grpSp>
        <p:nvGrpSpPr>
          <p:cNvPr id="232" name="Group 231">
            <a:extLst>
              <a:ext uri="{FF2B5EF4-FFF2-40B4-BE49-F238E27FC236}">
                <a16:creationId xmlns:a16="http://schemas.microsoft.com/office/drawing/2014/main" id="{9C975538-4092-40B3-82B0-138406B64234}"/>
              </a:ext>
            </a:extLst>
          </p:cNvPr>
          <p:cNvGrpSpPr/>
          <p:nvPr/>
        </p:nvGrpSpPr>
        <p:grpSpPr>
          <a:xfrm>
            <a:off x="5017296" y="-20259"/>
            <a:ext cx="2928785" cy="6878259"/>
            <a:chOff x="3717310" y="-8312"/>
            <a:chExt cx="2928785" cy="6878259"/>
          </a:xfrm>
        </p:grpSpPr>
        <p:pic>
          <p:nvPicPr>
            <p:cNvPr id="95" name="Picture 94" descr="A screenshot of a computer&#10;&#10;Description automatically generated with low confidence">
              <a:extLst>
                <a:ext uri="{FF2B5EF4-FFF2-40B4-BE49-F238E27FC236}">
                  <a16:creationId xmlns:a16="http://schemas.microsoft.com/office/drawing/2014/main" id="{37BB63F1-8EDB-477E-A0D5-E3D4958817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910" r="5217" b="11971"/>
            <a:stretch/>
          </p:blipFill>
          <p:spPr>
            <a:xfrm rot="5400000">
              <a:off x="2145758" y="2302481"/>
              <a:ext cx="6758176" cy="2242498"/>
            </a:xfrm>
            <a:prstGeom prst="rect">
              <a:avLst/>
            </a:prstGeom>
          </p:spPr>
        </p:pic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F40CA7BC-5AE3-4F82-AB03-4E625CE70C2C}"/>
                </a:ext>
              </a:extLst>
            </p:cNvPr>
            <p:cNvSpPr/>
            <p:nvPr/>
          </p:nvSpPr>
          <p:spPr>
            <a:xfrm>
              <a:off x="4505498" y="195017"/>
              <a:ext cx="145473" cy="603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CE2018DA-68E0-4E8A-B5ED-BD7FED6F7FA2}"/>
                </a:ext>
              </a:extLst>
            </p:cNvPr>
            <p:cNvSpPr/>
            <p:nvPr/>
          </p:nvSpPr>
          <p:spPr>
            <a:xfrm>
              <a:off x="4882342" y="198264"/>
              <a:ext cx="145473" cy="603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76158488-4535-4A29-B36A-517A7025A33F}"/>
                </a:ext>
              </a:extLst>
            </p:cNvPr>
            <p:cNvSpPr/>
            <p:nvPr/>
          </p:nvSpPr>
          <p:spPr>
            <a:xfrm>
              <a:off x="5259186" y="194347"/>
              <a:ext cx="145473" cy="603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66005908-C7BF-45D8-AE5F-7568ACB9A93F}"/>
                </a:ext>
              </a:extLst>
            </p:cNvPr>
            <p:cNvSpPr txBox="1"/>
            <p:nvPr/>
          </p:nvSpPr>
          <p:spPr>
            <a:xfrm>
              <a:off x="4403598" y="124482"/>
              <a:ext cx="3882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VCAP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AE5454F1-DD98-4BFD-AC28-9F1DBA7FD385}"/>
                </a:ext>
              </a:extLst>
            </p:cNvPr>
            <p:cNvSpPr txBox="1"/>
            <p:nvPr/>
          </p:nvSpPr>
          <p:spPr>
            <a:xfrm>
              <a:off x="4743321" y="124481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22RV1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2CD6A0CA-21DB-4253-BEF9-9079A2F47DE5}"/>
                </a:ext>
              </a:extLst>
            </p:cNvPr>
            <p:cNvSpPr txBox="1"/>
            <p:nvPr/>
          </p:nvSpPr>
          <p:spPr>
            <a:xfrm>
              <a:off x="5118311" y="124480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NCaP</a:t>
              </a:r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A3C29501-71AA-47A3-9158-EB594965FE03}"/>
                </a:ext>
              </a:extLst>
            </p:cNvPr>
            <p:cNvSpPr/>
            <p:nvPr/>
          </p:nvSpPr>
          <p:spPr>
            <a:xfrm>
              <a:off x="5619404" y="206794"/>
              <a:ext cx="169558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B0059DE0-8F89-4249-AD64-E89091C993BA}"/>
                </a:ext>
              </a:extLst>
            </p:cNvPr>
            <p:cNvSpPr/>
            <p:nvPr/>
          </p:nvSpPr>
          <p:spPr>
            <a:xfrm>
              <a:off x="5996248" y="209624"/>
              <a:ext cx="169558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51425B0E-1864-48B5-866B-B1D7F809993E}"/>
                </a:ext>
              </a:extLst>
            </p:cNvPr>
            <p:cNvSpPr/>
            <p:nvPr/>
          </p:nvSpPr>
          <p:spPr>
            <a:xfrm>
              <a:off x="6390659" y="206794"/>
              <a:ext cx="169558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681A6DEE-5F81-4A31-9AA8-9956AFC23F8A}"/>
                </a:ext>
              </a:extLst>
            </p:cNvPr>
            <p:cNvSpPr txBox="1"/>
            <p:nvPr/>
          </p:nvSpPr>
          <p:spPr>
            <a:xfrm>
              <a:off x="5506558" y="124479"/>
              <a:ext cx="4315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C-3M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0115EF54-0D2C-4D26-91C3-3E9214A6E878}"/>
                </a:ext>
              </a:extLst>
            </p:cNvPr>
            <p:cNvSpPr txBox="1"/>
            <p:nvPr/>
          </p:nvSpPr>
          <p:spPr>
            <a:xfrm>
              <a:off x="5862625" y="124143"/>
              <a:ext cx="4347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DU145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5274CEE6-E620-462F-9DF4-C9115165F8A2}"/>
                </a:ext>
              </a:extLst>
            </p:cNvPr>
            <p:cNvSpPr txBox="1"/>
            <p:nvPr/>
          </p:nvSpPr>
          <p:spPr>
            <a:xfrm>
              <a:off x="6282862" y="128404"/>
              <a:ext cx="3529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C-3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9570A39D-CE9E-44DB-A499-C04B92371C4F}"/>
                </a:ext>
              </a:extLst>
            </p:cNvPr>
            <p:cNvSpPr txBox="1"/>
            <p:nvPr/>
          </p:nvSpPr>
          <p:spPr>
            <a:xfrm>
              <a:off x="4027817" y="217159"/>
              <a:ext cx="4683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FGFBP1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01AD41F8-CCA3-42A8-BA89-7456BB82FA5C}"/>
                </a:ext>
              </a:extLst>
            </p:cNvPr>
            <p:cNvSpPr txBox="1"/>
            <p:nvPr/>
          </p:nvSpPr>
          <p:spPr>
            <a:xfrm>
              <a:off x="3909633" y="277917"/>
              <a:ext cx="5870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MIR100HG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92CB7507-15D9-4F8D-930A-3CF1EDA6CEB1}"/>
                </a:ext>
              </a:extLst>
            </p:cNvPr>
            <p:cNvSpPr txBox="1"/>
            <p:nvPr/>
          </p:nvSpPr>
          <p:spPr>
            <a:xfrm>
              <a:off x="4030222" y="345201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RDM8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6C56F270-DBFF-46D6-A301-851E6E8C91D4}"/>
                </a:ext>
              </a:extLst>
            </p:cNvPr>
            <p:cNvSpPr txBox="1"/>
            <p:nvPr/>
          </p:nvSpPr>
          <p:spPr>
            <a:xfrm>
              <a:off x="4019878" y="413176"/>
              <a:ext cx="47160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IGF BP6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088120C7-70B0-4BF1-8D4E-8926D218CDD8}"/>
                </a:ext>
              </a:extLst>
            </p:cNvPr>
            <p:cNvSpPr txBox="1"/>
            <p:nvPr/>
          </p:nvSpPr>
          <p:spPr>
            <a:xfrm>
              <a:off x="3978632" y="472891"/>
              <a:ext cx="5132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MICB-DT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4A832392-23A5-40F2-B3E3-4C0FD9F08261}"/>
                </a:ext>
              </a:extLst>
            </p:cNvPr>
            <p:cNvSpPr txBox="1"/>
            <p:nvPr/>
          </p:nvSpPr>
          <p:spPr>
            <a:xfrm>
              <a:off x="3921562" y="541504"/>
              <a:ext cx="5790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INC00857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97628996-0354-43CF-A1CC-C92357423315}"/>
                </a:ext>
              </a:extLst>
            </p:cNvPr>
            <p:cNvSpPr txBox="1"/>
            <p:nvPr/>
          </p:nvSpPr>
          <p:spPr>
            <a:xfrm>
              <a:off x="4025078" y="661922"/>
              <a:ext cx="46519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SIR PB1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E10C62D6-352C-48A6-A113-820D43E34887}"/>
                </a:ext>
              </a:extLst>
            </p:cNvPr>
            <p:cNvSpPr txBox="1"/>
            <p:nvPr/>
          </p:nvSpPr>
          <p:spPr>
            <a:xfrm>
              <a:off x="3759485" y="600581"/>
              <a:ext cx="73609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OC105747689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D2824111-D20C-4AC9-B908-9638FE6250BE}"/>
                </a:ext>
              </a:extLst>
            </p:cNvPr>
            <p:cNvSpPr txBox="1"/>
            <p:nvPr/>
          </p:nvSpPr>
          <p:spPr>
            <a:xfrm>
              <a:off x="4145830" y="729785"/>
              <a:ext cx="34336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DA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B37B3CA4-E58E-4678-910C-FC8862039992}"/>
                </a:ext>
              </a:extLst>
            </p:cNvPr>
            <p:cNvSpPr txBox="1"/>
            <p:nvPr/>
          </p:nvSpPr>
          <p:spPr>
            <a:xfrm>
              <a:off x="4033419" y="795555"/>
              <a:ext cx="4603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GALS3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C2038E18-2431-4E4D-B879-BE5EB369514B}"/>
                </a:ext>
              </a:extLst>
            </p:cNvPr>
            <p:cNvSpPr txBox="1"/>
            <p:nvPr/>
          </p:nvSpPr>
          <p:spPr>
            <a:xfrm>
              <a:off x="4125170" y="854632"/>
              <a:ext cx="3626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NOG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75685A52-6533-493F-A031-7444A50E4792}"/>
                </a:ext>
              </a:extLst>
            </p:cNvPr>
            <p:cNvSpPr txBox="1"/>
            <p:nvPr/>
          </p:nvSpPr>
          <p:spPr>
            <a:xfrm>
              <a:off x="4049614" y="924764"/>
              <a:ext cx="4363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FOXA2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DD703AF7-F3D8-4522-94D9-7BC40A95B838}"/>
                </a:ext>
              </a:extLst>
            </p:cNvPr>
            <p:cNvSpPr txBox="1"/>
            <p:nvPr/>
          </p:nvSpPr>
          <p:spPr>
            <a:xfrm>
              <a:off x="3988355" y="1250456"/>
              <a:ext cx="5100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YP27C1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581BC5E3-A025-461D-A21B-4D4F6EFE74A2}"/>
                </a:ext>
              </a:extLst>
            </p:cNvPr>
            <p:cNvSpPr txBox="1"/>
            <p:nvPr/>
          </p:nvSpPr>
          <p:spPr>
            <a:xfrm>
              <a:off x="4019944" y="1316700"/>
              <a:ext cx="4700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WNT7A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60C5524A-82C9-4643-ADC4-520B009E20DB}"/>
                </a:ext>
              </a:extLst>
            </p:cNvPr>
            <p:cNvSpPr txBox="1"/>
            <p:nvPr/>
          </p:nvSpPr>
          <p:spPr>
            <a:xfrm>
              <a:off x="4076538" y="1186279"/>
              <a:ext cx="41710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MYPN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BA8CE10A-B404-4B7A-9C60-0D567B68A900}"/>
                </a:ext>
              </a:extLst>
            </p:cNvPr>
            <p:cNvSpPr txBox="1"/>
            <p:nvPr/>
          </p:nvSpPr>
          <p:spPr>
            <a:xfrm>
              <a:off x="4100095" y="1120035"/>
              <a:ext cx="3882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TFPI2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CCABE955-0A57-4858-9C9B-CA74F85113D9}"/>
                </a:ext>
              </a:extLst>
            </p:cNvPr>
            <p:cNvSpPr txBox="1"/>
            <p:nvPr/>
          </p:nvSpPr>
          <p:spPr>
            <a:xfrm>
              <a:off x="3936012" y="1052407"/>
              <a:ext cx="55656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EACAM5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813D1965-1EB3-48C0-89EE-1A6403019AD7}"/>
                </a:ext>
              </a:extLst>
            </p:cNvPr>
            <p:cNvSpPr txBox="1"/>
            <p:nvPr/>
          </p:nvSpPr>
          <p:spPr>
            <a:xfrm>
              <a:off x="3988249" y="984682"/>
              <a:ext cx="50366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FAM20A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5731F4A2-C4ED-4EA7-AA89-A2E8F86FFDD7}"/>
                </a:ext>
              </a:extLst>
            </p:cNvPr>
            <p:cNvSpPr txBox="1"/>
            <p:nvPr/>
          </p:nvSpPr>
          <p:spPr>
            <a:xfrm>
              <a:off x="4083795" y="1382512"/>
              <a:ext cx="4058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ITGB4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5382E020-E1BF-4E56-8C77-17459331673F}"/>
                </a:ext>
              </a:extLst>
            </p:cNvPr>
            <p:cNvSpPr txBox="1"/>
            <p:nvPr/>
          </p:nvSpPr>
          <p:spPr>
            <a:xfrm>
              <a:off x="4052204" y="1442657"/>
              <a:ext cx="4443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ITGBL1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74BB2933-6C0B-45C6-9229-A94E82CE7018}"/>
                </a:ext>
              </a:extLst>
            </p:cNvPr>
            <p:cNvSpPr txBox="1"/>
            <p:nvPr/>
          </p:nvSpPr>
          <p:spPr>
            <a:xfrm>
              <a:off x="3932490" y="1503295"/>
              <a:ext cx="56297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MIR31H G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601DA157-E94D-4BC3-B7F4-AC8E63697865}"/>
                </a:ext>
              </a:extLst>
            </p:cNvPr>
            <p:cNvSpPr txBox="1"/>
            <p:nvPr/>
          </p:nvSpPr>
          <p:spPr>
            <a:xfrm>
              <a:off x="4074331" y="1567643"/>
              <a:ext cx="4203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FOXL1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FA82A236-B85A-401E-8421-D1EB64BC584E}"/>
                </a:ext>
              </a:extLst>
            </p:cNvPr>
            <p:cNvSpPr txBox="1"/>
            <p:nvPr/>
          </p:nvSpPr>
          <p:spPr>
            <a:xfrm>
              <a:off x="4116693" y="1636172"/>
              <a:ext cx="3738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EYA4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CEC60090-79A1-4DD8-B82D-4B17E780EE61}"/>
                </a:ext>
              </a:extLst>
            </p:cNvPr>
            <p:cNvSpPr txBox="1"/>
            <p:nvPr/>
          </p:nvSpPr>
          <p:spPr>
            <a:xfrm>
              <a:off x="3967884" y="1701296"/>
              <a:ext cx="52610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S100A 16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0B491B39-EF71-44A6-BDBF-1835D3ABD576}"/>
                </a:ext>
              </a:extLst>
            </p:cNvPr>
            <p:cNvSpPr txBox="1"/>
            <p:nvPr/>
          </p:nvSpPr>
          <p:spPr>
            <a:xfrm>
              <a:off x="4147085" y="1757778"/>
              <a:ext cx="34817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IER3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FF3CA900-18B7-4586-AE4D-07CBF5D0D6E0}"/>
                </a:ext>
              </a:extLst>
            </p:cNvPr>
            <p:cNvSpPr txBox="1"/>
            <p:nvPr/>
          </p:nvSpPr>
          <p:spPr>
            <a:xfrm>
              <a:off x="3915140" y="1818586"/>
              <a:ext cx="58221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APOBEC3C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0B063B20-026C-42E8-BA86-54650BEFF1C0}"/>
                </a:ext>
              </a:extLst>
            </p:cNvPr>
            <p:cNvSpPr txBox="1"/>
            <p:nvPr/>
          </p:nvSpPr>
          <p:spPr>
            <a:xfrm>
              <a:off x="3945145" y="1890931"/>
              <a:ext cx="54694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SERPINB7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C57A3961-8E2B-442A-86A4-13672D723742}"/>
                </a:ext>
              </a:extLst>
            </p:cNvPr>
            <p:cNvSpPr txBox="1"/>
            <p:nvPr/>
          </p:nvSpPr>
          <p:spPr>
            <a:xfrm>
              <a:off x="3902153" y="1957057"/>
              <a:ext cx="59503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INCO2323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C84923E4-AF03-45FF-AB63-980DE3FAC6DB}"/>
                </a:ext>
              </a:extLst>
            </p:cNvPr>
            <p:cNvSpPr txBox="1"/>
            <p:nvPr/>
          </p:nvSpPr>
          <p:spPr>
            <a:xfrm>
              <a:off x="4027367" y="2031872"/>
              <a:ext cx="4700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GNG 11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B4BC5A5E-CAA8-4AAA-A201-BB9410A2C961}"/>
                </a:ext>
              </a:extLst>
            </p:cNvPr>
            <p:cNvSpPr txBox="1"/>
            <p:nvPr/>
          </p:nvSpPr>
          <p:spPr>
            <a:xfrm>
              <a:off x="4139686" y="2092406"/>
              <a:ext cx="3529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IFNE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4F3757AF-2637-4AC3-937F-62DC4FEA1B72}"/>
                </a:ext>
              </a:extLst>
            </p:cNvPr>
            <p:cNvSpPr txBox="1"/>
            <p:nvPr/>
          </p:nvSpPr>
          <p:spPr>
            <a:xfrm>
              <a:off x="3717310" y="2150244"/>
              <a:ext cx="78098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OC1000126784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69AFBD2F-B51D-479C-AAB9-496C4862C1B2}"/>
                </a:ext>
              </a:extLst>
            </p:cNvPr>
            <p:cNvSpPr txBox="1"/>
            <p:nvPr/>
          </p:nvSpPr>
          <p:spPr>
            <a:xfrm>
              <a:off x="4150254" y="2214519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VIM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BCD0F2B9-5890-4C1A-B8D3-AB5FB9F222F2}"/>
                </a:ext>
              </a:extLst>
            </p:cNvPr>
            <p:cNvSpPr txBox="1"/>
            <p:nvPr/>
          </p:nvSpPr>
          <p:spPr>
            <a:xfrm>
              <a:off x="4137305" y="2343080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ID1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3F174B53-4602-4FFA-8CE1-5E76FEBFF864}"/>
                </a:ext>
              </a:extLst>
            </p:cNvPr>
            <p:cNvSpPr txBox="1"/>
            <p:nvPr/>
          </p:nvSpPr>
          <p:spPr>
            <a:xfrm>
              <a:off x="4037570" y="2279709"/>
              <a:ext cx="4539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NIPAL4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A65CB921-98EB-4C5E-A09B-3CFBD0BECE2C}"/>
                </a:ext>
              </a:extLst>
            </p:cNvPr>
            <p:cNvSpPr txBox="1"/>
            <p:nvPr/>
          </p:nvSpPr>
          <p:spPr>
            <a:xfrm>
              <a:off x="4130923" y="2407929"/>
              <a:ext cx="36420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TLR1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BEDFF66D-1C0B-44F2-A18A-A2BD2C3BA49B}"/>
                </a:ext>
              </a:extLst>
            </p:cNvPr>
            <p:cNvSpPr txBox="1"/>
            <p:nvPr/>
          </p:nvSpPr>
          <p:spPr>
            <a:xfrm>
              <a:off x="3840472" y="2478760"/>
              <a:ext cx="6575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WWTR1-AS1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EB2A8B62-7E9E-4C3D-852F-C04DAA0AC18B}"/>
                </a:ext>
              </a:extLst>
            </p:cNvPr>
            <p:cNvSpPr txBox="1"/>
            <p:nvPr/>
          </p:nvSpPr>
          <p:spPr>
            <a:xfrm>
              <a:off x="3899073" y="2538318"/>
              <a:ext cx="59503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INCO1806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11178B9F-B530-44AB-BAE3-27BC81376572}"/>
                </a:ext>
              </a:extLst>
            </p:cNvPr>
            <p:cNvSpPr txBox="1"/>
            <p:nvPr/>
          </p:nvSpPr>
          <p:spPr>
            <a:xfrm>
              <a:off x="3966870" y="2602027"/>
              <a:ext cx="53091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OLA4A1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CF96357A-A079-4D4D-AA91-49E55BEF2C0D}"/>
                </a:ext>
              </a:extLst>
            </p:cNvPr>
            <p:cNvSpPr txBox="1"/>
            <p:nvPr/>
          </p:nvSpPr>
          <p:spPr>
            <a:xfrm>
              <a:off x="4100133" y="2730056"/>
              <a:ext cx="39145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EDIL3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20BCAEC4-194C-45D8-B4F0-0004B185D010}"/>
                </a:ext>
              </a:extLst>
            </p:cNvPr>
            <p:cNvSpPr txBox="1"/>
            <p:nvPr/>
          </p:nvSpPr>
          <p:spPr>
            <a:xfrm>
              <a:off x="4080697" y="2667577"/>
              <a:ext cx="4138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XCL2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C97CE0EB-45D8-40C5-8586-E16DDA7DC6ED}"/>
                </a:ext>
              </a:extLst>
            </p:cNvPr>
            <p:cNvSpPr txBox="1"/>
            <p:nvPr/>
          </p:nvSpPr>
          <p:spPr>
            <a:xfrm>
              <a:off x="4134002" y="2795922"/>
              <a:ext cx="3609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SF2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7AF1A446-2B53-49FD-829F-B14EC77ADF73}"/>
                </a:ext>
              </a:extLst>
            </p:cNvPr>
            <p:cNvSpPr txBox="1"/>
            <p:nvPr/>
          </p:nvSpPr>
          <p:spPr>
            <a:xfrm>
              <a:off x="4109367" y="2865179"/>
              <a:ext cx="3850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AV1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E138D0A9-0590-49CA-B220-CC169700402E}"/>
                </a:ext>
              </a:extLst>
            </p:cNvPr>
            <p:cNvSpPr txBox="1"/>
            <p:nvPr/>
          </p:nvSpPr>
          <p:spPr>
            <a:xfrm>
              <a:off x="4109624" y="2925694"/>
              <a:ext cx="3850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AV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4F66C1A7-5A9A-47D4-A716-97ECF45F951F}"/>
                </a:ext>
              </a:extLst>
            </p:cNvPr>
            <p:cNvSpPr txBox="1"/>
            <p:nvPr/>
          </p:nvSpPr>
          <p:spPr>
            <a:xfrm>
              <a:off x="4071898" y="3053978"/>
              <a:ext cx="4219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GSTP1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9DC66C3B-1A90-4E94-9AC7-29A287497CB3}"/>
                </a:ext>
              </a:extLst>
            </p:cNvPr>
            <p:cNvSpPr txBox="1"/>
            <p:nvPr/>
          </p:nvSpPr>
          <p:spPr>
            <a:xfrm>
              <a:off x="4149645" y="2991951"/>
              <a:ext cx="34336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NGF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BFE3F801-3665-4B93-A071-20B3F3DF8789}"/>
                </a:ext>
              </a:extLst>
            </p:cNvPr>
            <p:cNvSpPr txBox="1"/>
            <p:nvPr/>
          </p:nvSpPr>
          <p:spPr>
            <a:xfrm>
              <a:off x="4026987" y="3116182"/>
              <a:ext cx="4700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LAAT1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D489D81B-9B7E-4E56-B3F9-9F8FA7A78778}"/>
                </a:ext>
              </a:extLst>
            </p:cNvPr>
            <p:cNvSpPr txBox="1"/>
            <p:nvPr/>
          </p:nvSpPr>
          <p:spPr>
            <a:xfrm>
              <a:off x="4127691" y="3179270"/>
              <a:ext cx="36580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FHL2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F5F513F5-58F4-4EAF-820D-94325486BA8C}"/>
                </a:ext>
              </a:extLst>
            </p:cNvPr>
            <p:cNvSpPr txBox="1"/>
            <p:nvPr/>
          </p:nvSpPr>
          <p:spPr>
            <a:xfrm>
              <a:off x="4007613" y="3255970"/>
              <a:ext cx="4796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MMP14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091945FB-76B8-4090-A479-9787184BE5CA}"/>
                </a:ext>
              </a:extLst>
            </p:cNvPr>
            <p:cNvSpPr txBox="1"/>
            <p:nvPr/>
          </p:nvSpPr>
          <p:spPr>
            <a:xfrm>
              <a:off x="4127249" y="3313633"/>
              <a:ext cx="3674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KLK5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534719A1-5279-49F8-834B-2C49C0921512}"/>
                </a:ext>
              </a:extLst>
            </p:cNvPr>
            <p:cNvSpPr txBox="1"/>
            <p:nvPr/>
          </p:nvSpPr>
          <p:spPr>
            <a:xfrm>
              <a:off x="4056877" y="3379947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FOSL 1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6D894B75-0ACC-4CA9-816E-FAB2FE15C53C}"/>
                </a:ext>
              </a:extLst>
            </p:cNvPr>
            <p:cNvSpPr txBox="1"/>
            <p:nvPr/>
          </p:nvSpPr>
          <p:spPr>
            <a:xfrm>
              <a:off x="4115376" y="3446818"/>
              <a:ext cx="3738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STA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73BDA29D-0486-451D-95F5-9901D9D6941B}"/>
                </a:ext>
              </a:extLst>
            </p:cNvPr>
            <p:cNvSpPr txBox="1"/>
            <p:nvPr/>
          </p:nvSpPr>
          <p:spPr>
            <a:xfrm>
              <a:off x="4061560" y="3508018"/>
              <a:ext cx="4315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LDN8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AD454920-0E45-4FE3-B82C-43003C5C816B}"/>
                </a:ext>
              </a:extLst>
            </p:cNvPr>
            <p:cNvSpPr txBox="1"/>
            <p:nvPr/>
          </p:nvSpPr>
          <p:spPr>
            <a:xfrm>
              <a:off x="4099827" y="3573445"/>
              <a:ext cx="39305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HRH3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A30B6737-72C8-49F5-8655-3613BBF72E2A}"/>
                </a:ext>
              </a:extLst>
            </p:cNvPr>
            <p:cNvSpPr txBox="1"/>
            <p:nvPr/>
          </p:nvSpPr>
          <p:spPr>
            <a:xfrm>
              <a:off x="3945020" y="3637854"/>
              <a:ext cx="55015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CDHGA2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27BDBA89-DCC0-453E-9CBC-0A1EC1B177ED}"/>
                </a:ext>
              </a:extLst>
            </p:cNvPr>
            <p:cNvSpPr txBox="1"/>
            <p:nvPr/>
          </p:nvSpPr>
          <p:spPr>
            <a:xfrm>
              <a:off x="4126741" y="3702474"/>
              <a:ext cx="3674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GJB1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8508DB2E-C864-4D3A-9221-F1C02BC8A2A9}"/>
                </a:ext>
              </a:extLst>
            </p:cNvPr>
            <p:cNvSpPr txBox="1"/>
            <p:nvPr/>
          </p:nvSpPr>
          <p:spPr>
            <a:xfrm>
              <a:off x="3982981" y="3770224"/>
              <a:ext cx="5132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OLEC12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8AB9A364-1F25-45CB-84C9-57144EB07090}"/>
                </a:ext>
              </a:extLst>
            </p:cNvPr>
            <p:cNvSpPr txBox="1"/>
            <p:nvPr/>
          </p:nvSpPr>
          <p:spPr>
            <a:xfrm>
              <a:off x="4041482" y="3829721"/>
              <a:ext cx="4555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SARM1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7D7E0FEC-38B1-48E9-85F5-ACF5901CDC3E}"/>
                </a:ext>
              </a:extLst>
            </p:cNvPr>
            <p:cNvSpPr txBox="1"/>
            <p:nvPr/>
          </p:nvSpPr>
          <p:spPr>
            <a:xfrm>
              <a:off x="3992218" y="4154306"/>
              <a:ext cx="50206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SEMA4A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DF065361-E045-4850-AFB5-24256042A96C}"/>
                </a:ext>
              </a:extLst>
            </p:cNvPr>
            <p:cNvSpPr txBox="1"/>
            <p:nvPr/>
          </p:nvSpPr>
          <p:spPr>
            <a:xfrm>
              <a:off x="4182670" y="3892591"/>
              <a:ext cx="3097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ID4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55CD3025-9713-438C-9B53-876E1C0331BD}"/>
                </a:ext>
              </a:extLst>
            </p:cNvPr>
            <p:cNvSpPr txBox="1"/>
            <p:nvPr/>
          </p:nvSpPr>
          <p:spPr>
            <a:xfrm>
              <a:off x="3867594" y="3959832"/>
              <a:ext cx="63190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MIR4458HG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9CFE1E12-6B7E-419C-BCFD-52ABEFDC46E5}"/>
                </a:ext>
              </a:extLst>
            </p:cNvPr>
            <p:cNvSpPr txBox="1"/>
            <p:nvPr/>
          </p:nvSpPr>
          <p:spPr>
            <a:xfrm>
              <a:off x="4110297" y="4024091"/>
              <a:ext cx="3834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TARP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0D608D24-C225-4E0D-B776-D704AC6DEF4D}"/>
                </a:ext>
              </a:extLst>
            </p:cNvPr>
            <p:cNvSpPr txBox="1"/>
            <p:nvPr/>
          </p:nvSpPr>
          <p:spPr>
            <a:xfrm>
              <a:off x="3951136" y="4093873"/>
              <a:ext cx="54694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AC SIN 1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B848EBE6-AC9C-463D-806F-81FFD3838D92}"/>
                </a:ext>
              </a:extLst>
            </p:cNvPr>
            <p:cNvSpPr txBox="1"/>
            <p:nvPr/>
          </p:nvSpPr>
          <p:spPr>
            <a:xfrm>
              <a:off x="3989139" y="4216033"/>
              <a:ext cx="5068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ASKIN1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CEDA40B9-9B8F-4E92-A006-D7D2124FA904}"/>
                </a:ext>
              </a:extLst>
            </p:cNvPr>
            <p:cNvSpPr txBox="1"/>
            <p:nvPr/>
          </p:nvSpPr>
          <p:spPr>
            <a:xfrm>
              <a:off x="4114705" y="4279467"/>
              <a:ext cx="3738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TBX3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DE78703C-254E-43D2-977D-C79275858B28}"/>
                </a:ext>
              </a:extLst>
            </p:cNvPr>
            <p:cNvSpPr txBox="1"/>
            <p:nvPr/>
          </p:nvSpPr>
          <p:spPr>
            <a:xfrm>
              <a:off x="3958352" y="4345093"/>
              <a:ext cx="53412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METTL7A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2A90E59E-75BA-43B6-87FC-C1B07B6089EA}"/>
                </a:ext>
              </a:extLst>
            </p:cNvPr>
            <p:cNvSpPr txBox="1"/>
            <p:nvPr/>
          </p:nvSpPr>
          <p:spPr>
            <a:xfrm>
              <a:off x="3960800" y="4407369"/>
              <a:ext cx="53412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TCERG 1L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683D2FDE-7FAF-4E6A-84EF-29D96FDE8E41}"/>
                </a:ext>
              </a:extLst>
            </p:cNvPr>
            <p:cNvSpPr txBox="1"/>
            <p:nvPr/>
          </p:nvSpPr>
          <p:spPr>
            <a:xfrm>
              <a:off x="4084190" y="4476264"/>
              <a:ext cx="41229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RHOU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97698895-4445-4A4E-9848-443D4478C466}"/>
                </a:ext>
              </a:extLst>
            </p:cNvPr>
            <p:cNvSpPr txBox="1"/>
            <p:nvPr/>
          </p:nvSpPr>
          <p:spPr>
            <a:xfrm>
              <a:off x="4006771" y="4543633"/>
              <a:ext cx="46198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ZBTB32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B308481E-C9E5-47D9-AA16-7F00FE431FC1}"/>
                </a:ext>
              </a:extLst>
            </p:cNvPr>
            <p:cNvSpPr txBox="1"/>
            <p:nvPr/>
          </p:nvSpPr>
          <p:spPr>
            <a:xfrm>
              <a:off x="3993204" y="4604124"/>
              <a:ext cx="50206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SEMA6A</a:t>
              </a:r>
            </a:p>
          </p:txBody>
        </p:sp>
        <p:sp>
          <p:nvSpPr>
            <p:cNvPr id="188" name="Rectangle 187">
              <a:extLst>
                <a:ext uri="{FF2B5EF4-FFF2-40B4-BE49-F238E27FC236}">
                  <a16:creationId xmlns:a16="http://schemas.microsoft.com/office/drawing/2014/main" id="{AAF5796E-0055-4BDC-9AE1-C056C33A3DDA}"/>
                </a:ext>
              </a:extLst>
            </p:cNvPr>
            <p:cNvSpPr/>
            <p:nvPr/>
          </p:nvSpPr>
          <p:spPr>
            <a:xfrm>
              <a:off x="4772018" y="93402"/>
              <a:ext cx="344784" cy="6181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B153F75C-2168-405C-8962-FDB2B6DED6F2}"/>
                </a:ext>
              </a:extLst>
            </p:cNvPr>
            <p:cNvSpPr txBox="1"/>
            <p:nvPr/>
          </p:nvSpPr>
          <p:spPr>
            <a:xfrm>
              <a:off x="4568519" y="-8312"/>
              <a:ext cx="86914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R</a:t>
              </a:r>
              <a:r>
                <a:rPr lang="en-US" sz="900" b="1" baseline="30000" dirty="0"/>
                <a:t>HIGH</a:t>
              </a:r>
              <a:r>
                <a:rPr lang="en-US" sz="900" b="1" dirty="0"/>
                <a:t>/mCSPC</a:t>
              </a:r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18DAAF5B-17A9-4DA9-BA5B-2D5E1D59341E}"/>
                </a:ext>
              </a:extLst>
            </p:cNvPr>
            <p:cNvSpPr/>
            <p:nvPr/>
          </p:nvSpPr>
          <p:spPr>
            <a:xfrm>
              <a:off x="5951913" y="93402"/>
              <a:ext cx="293445" cy="57786"/>
            </a:xfrm>
            <a:prstGeom prst="rect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18EF4492-57AC-41FD-BF87-236278D6CBC3}"/>
                </a:ext>
              </a:extLst>
            </p:cNvPr>
            <p:cNvSpPr txBox="1"/>
            <p:nvPr/>
          </p:nvSpPr>
          <p:spPr>
            <a:xfrm>
              <a:off x="5710317" y="-6662"/>
              <a:ext cx="8451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R</a:t>
              </a:r>
              <a:r>
                <a:rPr lang="en-US" sz="900" b="1" baseline="30000" dirty="0"/>
                <a:t>Low</a:t>
              </a:r>
              <a:r>
                <a:rPr lang="en-US" sz="900" b="1" dirty="0"/>
                <a:t>/mCRPC</a:t>
              </a: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2D69D4CF-6E4F-478C-9A5E-8614CC24A248}"/>
                </a:ext>
              </a:extLst>
            </p:cNvPr>
            <p:cNvSpPr txBox="1"/>
            <p:nvPr/>
          </p:nvSpPr>
          <p:spPr>
            <a:xfrm>
              <a:off x="4001803" y="4670482"/>
              <a:ext cx="49564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MEGEE1</a:t>
              </a:r>
            </a:p>
          </p:txBody>
        </p: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9056882E-C1EF-4A31-8596-55EBFEA30B37}"/>
                </a:ext>
              </a:extLst>
            </p:cNvPr>
            <p:cNvSpPr txBox="1"/>
            <p:nvPr/>
          </p:nvSpPr>
          <p:spPr>
            <a:xfrm>
              <a:off x="3995101" y="4734926"/>
              <a:ext cx="4972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FOLH 1B</a:t>
              </a:r>
            </a:p>
          </p:txBody>
        </p: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F825BEAE-55D2-418B-9036-E2E88DED2C2F}"/>
                </a:ext>
              </a:extLst>
            </p:cNvPr>
            <p:cNvSpPr txBox="1"/>
            <p:nvPr/>
          </p:nvSpPr>
          <p:spPr>
            <a:xfrm>
              <a:off x="4033609" y="4800965"/>
              <a:ext cx="46198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ZBTB16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8E46BA65-0D3A-4746-B170-AB54A15298F5}"/>
                </a:ext>
              </a:extLst>
            </p:cNvPr>
            <p:cNvSpPr txBox="1"/>
            <p:nvPr/>
          </p:nvSpPr>
          <p:spPr>
            <a:xfrm>
              <a:off x="4066945" y="4861867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FXYD3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DCB5FB67-E7AB-454C-BE9C-E180294E71BB}"/>
                </a:ext>
              </a:extLst>
            </p:cNvPr>
            <p:cNvSpPr txBox="1"/>
            <p:nvPr/>
          </p:nvSpPr>
          <p:spPr>
            <a:xfrm>
              <a:off x="3878307" y="4920131"/>
              <a:ext cx="61747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1 OR t2 10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7E473A9A-6A15-4D0B-BF00-18625908D1DE}"/>
                </a:ext>
              </a:extLst>
            </p:cNvPr>
            <p:cNvSpPr txBox="1"/>
            <p:nvPr/>
          </p:nvSpPr>
          <p:spPr>
            <a:xfrm>
              <a:off x="4022265" y="4980564"/>
              <a:ext cx="4683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ROM2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A489D3B4-739A-452E-B331-B8D12179AD03}"/>
                </a:ext>
              </a:extLst>
            </p:cNvPr>
            <p:cNvSpPr txBox="1"/>
            <p:nvPr/>
          </p:nvSpPr>
          <p:spPr>
            <a:xfrm>
              <a:off x="4002628" y="5050394"/>
              <a:ext cx="49084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FAM83F</a:t>
              </a: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D002362D-8595-4F39-BDD7-E83EF51DBE8F}"/>
                </a:ext>
              </a:extLst>
            </p:cNvPr>
            <p:cNvSpPr txBox="1"/>
            <p:nvPr/>
          </p:nvSpPr>
          <p:spPr>
            <a:xfrm>
              <a:off x="3982785" y="5115253"/>
              <a:ext cx="5100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HOXC 12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6F40E187-2EED-4DC8-A8DA-DBCEDAAEBACA}"/>
                </a:ext>
              </a:extLst>
            </p:cNvPr>
            <p:cNvSpPr txBox="1"/>
            <p:nvPr/>
          </p:nvSpPr>
          <p:spPr>
            <a:xfrm>
              <a:off x="3760426" y="5177902"/>
              <a:ext cx="73609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OC100128770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0706A64B-243D-4FA1-8A7D-36CF4FE3DDCD}"/>
                </a:ext>
              </a:extLst>
            </p:cNvPr>
            <p:cNvSpPr txBox="1"/>
            <p:nvPr/>
          </p:nvSpPr>
          <p:spPr>
            <a:xfrm>
              <a:off x="3986520" y="5249003"/>
              <a:ext cx="5100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GLYATL1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EB21DF29-8C5E-4AB2-82BC-0B394C25C483}"/>
                </a:ext>
              </a:extLst>
            </p:cNvPr>
            <p:cNvSpPr txBox="1"/>
            <p:nvPr/>
          </p:nvSpPr>
          <p:spPr>
            <a:xfrm>
              <a:off x="3972466" y="5310244"/>
              <a:ext cx="5245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DLRAD1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AB731F5E-7FE7-42DD-BCF2-13FBD60C8DD1}"/>
                </a:ext>
              </a:extLst>
            </p:cNvPr>
            <p:cNvSpPr txBox="1"/>
            <p:nvPr/>
          </p:nvSpPr>
          <p:spPr>
            <a:xfrm>
              <a:off x="4013919" y="5383420"/>
              <a:ext cx="4812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TM7SF2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BC481FF8-8C13-4419-8C23-93CF0850569E}"/>
                </a:ext>
              </a:extLst>
            </p:cNvPr>
            <p:cNvSpPr txBox="1"/>
            <p:nvPr/>
          </p:nvSpPr>
          <p:spPr>
            <a:xfrm>
              <a:off x="4033981" y="5448658"/>
              <a:ext cx="4603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NKX3-1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D6D60B28-2A87-41AE-B252-20FA5F593FAD}"/>
                </a:ext>
              </a:extLst>
            </p:cNvPr>
            <p:cNvSpPr txBox="1"/>
            <p:nvPr/>
          </p:nvSpPr>
          <p:spPr>
            <a:xfrm>
              <a:off x="4066113" y="5513911"/>
              <a:ext cx="4299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MAF B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11C45EA2-C74B-4781-B67A-81CAC3AECA97}"/>
                </a:ext>
              </a:extLst>
            </p:cNvPr>
            <p:cNvSpPr txBox="1"/>
            <p:nvPr/>
          </p:nvSpPr>
          <p:spPr>
            <a:xfrm>
              <a:off x="4130566" y="5575603"/>
              <a:ext cx="35939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NDN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F2E2B605-F9AD-4BD9-B29F-071ACF4A51A0}"/>
                </a:ext>
              </a:extLst>
            </p:cNvPr>
            <p:cNvSpPr txBox="1"/>
            <p:nvPr/>
          </p:nvSpPr>
          <p:spPr>
            <a:xfrm>
              <a:off x="3964575" y="5637023"/>
              <a:ext cx="5293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ALDH3B2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313973D3-C639-43B0-ACD5-B151F5A8C771}"/>
                </a:ext>
              </a:extLst>
            </p:cNvPr>
            <p:cNvSpPr txBox="1"/>
            <p:nvPr/>
          </p:nvSpPr>
          <p:spPr>
            <a:xfrm>
              <a:off x="4112168" y="5701540"/>
              <a:ext cx="3802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EPN3</a:t>
              </a: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D9DAF14C-8726-40C4-A5BD-CC9D04ED80B7}"/>
                </a:ext>
              </a:extLst>
            </p:cNvPr>
            <p:cNvSpPr txBox="1"/>
            <p:nvPr/>
          </p:nvSpPr>
          <p:spPr>
            <a:xfrm>
              <a:off x="4032046" y="5768232"/>
              <a:ext cx="46198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STEAP2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B18359D7-9432-430D-A1AB-2322EB821AF0}"/>
                </a:ext>
              </a:extLst>
            </p:cNvPr>
            <p:cNvSpPr txBox="1"/>
            <p:nvPr/>
          </p:nvSpPr>
          <p:spPr>
            <a:xfrm>
              <a:off x="4058955" y="5827683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GRHL2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BAEDB1D3-33D4-4D5C-9C27-696A8B326B4B}"/>
                </a:ext>
              </a:extLst>
            </p:cNvPr>
            <p:cNvSpPr txBox="1"/>
            <p:nvPr/>
          </p:nvSpPr>
          <p:spPr>
            <a:xfrm>
              <a:off x="4000603" y="5905872"/>
              <a:ext cx="49084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RUNE2</a:t>
              </a: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87509964-1D34-40B7-B228-F7FC74A841BE}"/>
                </a:ext>
              </a:extLst>
            </p:cNvPr>
            <p:cNvSpPr txBox="1"/>
            <p:nvPr/>
          </p:nvSpPr>
          <p:spPr>
            <a:xfrm>
              <a:off x="3967585" y="5967461"/>
              <a:ext cx="51488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LA2G4F</a:t>
              </a: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E7FF2C90-A907-448E-820C-591459FC43ED}"/>
                </a:ext>
              </a:extLst>
            </p:cNvPr>
            <p:cNvSpPr txBox="1"/>
            <p:nvPr/>
          </p:nvSpPr>
          <p:spPr>
            <a:xfrm>
              <a:off x="4084385" y="6029262"/>
              <a:ext cx="40107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TMC4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5CE37434-3C9F-4AE2-B916-AA7D09319C31}"/>
                </a:ext>
              </a:extLst>
            </p:cNvPr>
            <p:cNvSpPr txBox="1"/>
            <p:nvPr/>
          </p:nvSpPr>
          <p:spPr>
            <a:xfrm>
              <a:off x="3966178" y="6088571"/>
              <a:ext cx="52610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RBBP8NL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AA1F3402-293F-429D-8F29-DA7DC54B3F7F}"/>
                </a:ext>
              </a:extLst>
            </p:cNvPr>
            <p:cNvSpPr txBox="1"/>
            <p:nvPr/>
          </p:nvSpPr>
          <p:spPr>
            <a:xfrm>
              <a:off x="4030719" y="6155814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PRR15L</a:t>
              </a: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2F054DC0-D7A1-499D-8BAB-7366CC226D19}"/>
                </a:ext>
              </a:extLst>
            </p:cNvPr>
            <p:cNvSpPr txBox="1"/>
            <p:nvPr/>
          </p:nvSpPr>
          <p:spPr>
            <a:xfrm>
              <a:off x="4068616" y="6219243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FOLH1</a:t>
              </a: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EC894910-5EA8-4EED-878B-3FF417CFB3BE}"/>
                </a:ext>
              </a:extLst>
            </p:cNvPr>
            <p:cNvSpPr txBox="1"/>
            <p:nvPr/>
          </p:nvSpPr>
          <p:spPr>
            <a:xfrm>
              <a:off x="4066111" y="6283956"/>
              <a:ext cx="4203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SYNE4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B6279F98-1011-49D1-996A-5D51A2BD4834}"/>
                </a:ext>
              </a:extLst>
            </p:cNvPr>
            <p:cNvSpPr txBox="1"/>
            <p:nvPr/>
          </p:nvSpPr>
          <p:spPr>
            <a:xfrm>
              <a:off x="3992345" y="6344394"/>
              <a:ext cx="5004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ADRA2A</a:t>
              </a:r>
            </a:p>
          </p:txBody>
        </p: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CB19E035-348C-4BC1-853F-14220B30AB8C}"/>
                </a:ext>
              </a:extLst>
            </p:cNvPr>
            <p:cNvSpPr txBox="1"/>
            <p:nvPr/>
          </p:nvSpPr>
          <p:spPr>
            <a:xfrm>
              <a:off x="3964508" y="6411002"/>
              <a:ext cx="53091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UGT2B17</a:t>
              </a: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E669B611-FFA4-49BA-9112-0A841B282F76}"/>
                </a:ext>
              </a:extLst>
            </p:cNvPr>
            <p:cNvSpPr txBox="1"/>
            <p:nvPr/>
          </p:nvSpPr>
          <p:spPr>
            <a:xfrm>
              <a:off x="4053309" y="6476382"/>
              <a:ext cx="43794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NETO1</a:t>
              </a: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F604752B-124C-4F24-9965-9DF50849F8DE}"/>
                </a:ext>
              </a:extLst>
            </p:cNvPr>
            <p:cNvSpPr txBox="1"/>
            <p:nvPr/>
          </p:nvSpPr>
          <p:spPr>
            <a:xfrm>
              <a:off x="4062128" y="6541879"/>
              <a:ext cx="4299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RRN1</a:t>
              </a: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4D982C76-6C32-4A63-BEA0-F3AA78299B95}"/>
                </a:ext>
              </a:extLst>
            </p:cNvPr>
            <p:cNvSpPr txBox="1"/>
            <p:nvPr/>
          </p:nvSpPr>
          <p:spPr>
            <a:xfrm>
              <a:off x="3760392" y="6607665"/>
              <a:ext cx="73609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OC105369209</a:t>
              </a: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BE0E06D0-540F-4F4C-B876-35EED35966DD}"/>
                </a:ext>
              </a:extLst>
            </p:cNvPr>
            <p:cNvSpPr txBox="1"/>
            <p:nvPr/>
          </p:nvSpPr>
          <p:spPr>
            <a:xfrm>
              <a:off x="3992566" y="6669892"/>
              <a:ext cx="50206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SLC13A3</a:t>
              </a:r>
            </a:p>
          </p:txBody>
        </p:sp>
        <p:cxnSp>
          <p:nvCxnSpPr>
            <p:cNvPr id="225" name="Straight Connector 224">
              <a:extLst>
                <a:ext uri="{FF2B5EF4-FFF2-40B4-BE49-F238E27FC236}">
                  <a16:creationId xmlns:a16="http://schemas.microsoft.com/office/drawing/2014/main" id="{BDB76D71-3530-4D3C-B869-B6E2C41FB1B3}"/>
                </a:ext>
              </a:extLst>
            </p:cNvPr>
            <p:cNvCxnSpPr>
              <a:cxnSpLocks/>
            </p:cNvCxnSpPr>
            <p:nvPr/>
          </p:nvCxnSpPr>
          <p:spPr>
            <a:xfrm>
              <a:off x="4403597" y="49667"/>
              <a:ext cx="3977" cy="23317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</p:grpSp>
      <p:sp>
        <p:nvSpPr>
          <p:cNvPr id="78" name="TextBox 77">
            <a:extLst>
              <a:ext uri="{FF2B5EF4-FFF2-40B4-BE49-F238E27FC236}">
                <a16:creationId xmlns:a16="http://schemas.microsoft.com/office/drawing/2014/main" id="{1E56EE9C-A7DF-4A3A-90BD-F4001094A56F}"/>
              </a:ext>
            </a:extLst>
          </p:cNvPr>
          <p:cNvSpPr txBox="1"/>
          <p:nvPr/>
        </p:nvSpPr>
        <p:spPr>
          <a:xfrm>
            <a:off x="2174577" y="91151"/>
            <a:ext cx="6479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srgbClr val="1E03BD"/>
                </a:solidFill>
              </a:rPr>
              <a:t>FDR&lt;0.5</a:t>
            </a:r>
          </a:p>
        </p:txBody>
      </p:sp>
      <p:sp>
        <p:nvSpPr>
          <p:cNvPr id="306" name="TextBox 305">
            <a:extLst>
              <a:ext uri="{FF2B5EF4-FFF2-40B4-BE49-F238E27FC236}">
                <a16:creationId xmlns:a16="http://schemas.microsoft.com/office/drawing/2014/main" id="{903E776D-CF67-442B-9C47-96CD7D4DA1A6}"/>
              </a:ext>
            </a:extLst>
          </p:cNvPr>
          <p:cNvSpPr txBox="1"/>
          <p:nvPr/>
        </p:nvSpPr>
        <p:spPr>
          <a:xfrm>
            <a:off x="5128449" y="86167"/>
            <a:ext cx="64472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srgbClr val="1E03BD"/>
                </a:solidFill>
              </a:rPr>
              <a:t>Top-100</a:t>
            </a:r>
          </a:p>
        </p:txBody>
      </p:sp>
      <p:pic>
        <p:nvPicPr>
          <p:cNvPr id="323" name="Picture 322">
            <a:extLst>
              <a:ext uri="{FF2B5EF4-FFF2-40B4-BE49-F238E27FC236}">
                <a16:creationId xmlns:a16="http://schemas.microsoft.com/office/drawing/2014/main" id="{CF8499E9-FC1D-4506-9DC5-C244C634AEE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0261" t="383" r="1790" b="82021"/>
          <a:stretch/>
        </p:blipFill>
        <p:spPr>
          <a:xfrm>
            <a:off x="7977763" y="54392"/>
            <a:ext cx="343691" cy="1024615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D2F5E0E9-408C-414C-8506-B65745B3BE51}"/>
              </a:ext>
            </a:extLst>
          </p:cNvPr>
          <p:cNvSpPr/>
          <p:nvPr/>
        </p:nvSpPr>
        <p:spPr>
          <a:xfrm>
            <a:off x="1991171" y="6796"/>
            <a:ext cx="6392253" cy="68255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6B745D6F-F7B3-4E00-9A0F-086FCED74D6C}"/>
              </a:ext>
            </a:extLst>
          </p:cNvPr>
          <p:cNvSpPr txBox="1"/>
          <p:nvPr/>
        </p:nvSpPr>
        <p:spPr>
          <a:xfrm>
            <a:off x="62845" y="71644"/>
            <a:ext cx="1884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967375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36</TotalTime>
  <Words>379</Words>
  <Application>Microsoft Office PowerPoint</Application>
  <PresentationFormat>Widescreen</PresentationFormat>
  <Paragraphs>19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swi Mitra Ghosh</dc:creator>
  <cp:lastModifiedBy>AMIT MITRA</cp:lastModifiedBy>
  <cp:revision>114</cp:revision>
  <cp:lastPrinted>2022-04-06T04:19:54Z</cp:lastPrinted>
  <dcterms:created xsi:type="dcterms:W3CDTF">2021-11-23T16:14:52Z</dcterms:created>
  <dcterms:modified xsi:type="dcterms:W3CDTF">2023-05-31T16:08:58Z</dcterms:modified>
</cp:coreProperties>
</file>